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5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3" name="Group 112"/>
          <p:cNvGrpSpPr/>
          <p:nvPr/>
        </p:nvGrpSpPr>
        <p:grpSpPr>
          <a:xfrm>
            <a:off x="388621" y="608569"/>
            <a:ext cx="6073141" cy="2396169"/>
            <a:chOff x="388620" y="379968"/>
            <a:chExt cx="6073141" cy="2396169"/>
          </a:xfrm>
        </p:grpSpPr>
        <p:sp>
          <p:nvSpPr>
            <p:cNvPr id="38" name="TextBox 37"/>
            <p:cNvSpPr txBox="1"/>
            <p:nvPr/>
          </p:nvSpPr>
          <p:spPr>
            <a:xfrm>
              <a:off x="494030" y="379968"/>
              <a:ext cx="3784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8" name="Picture 4" descr="C:\Users\PENG\Desktop\Picture2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0120" y="1404537"/>
              <a:ext cx="5501641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2" name="TextBox 51"/>
            <p:cNvSpPr txBox="1"/>
            <p:nvPr/>
          </p:nvSpPr>
          <p:spPr>
            <a:xfrm>
              <a:off x="906780" y="121681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099820" y="121681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292860" y="121681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485900" y="121681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4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678940" y="121681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871980" y="121681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1892384" y="1059249"/>
              <a:ext cx="612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4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s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+/-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970894" y="993056"/>
              <a:ext cx="13652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1318260" y="787316"/>
              <a:ext cx="6757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2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88620" y="1202437"/>
              <a:ext cx="6146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S</a:t>
              </a:r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mple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11480" y="762000"/>
              <a:ext cx="6146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Primer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4" name="Straight Connector 103"/>
            <p:cNvCxnSpPr/>
            <p:nvPr/>
          </p:nvCxnSpPr>
          <p:spPr>
            <a:xfrm>
              <a:off x="474980" y="993056"/>
              <a:ext cx="373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/>
            <p:nvPr/>
          </p:nvSpPr>
          <p:spPr>
            <a:xfrm>
              <a:off x="2456794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2649834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842874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3035914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4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228954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3421994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 rot="16200000">
              <a:off x="3442398" y="1066869"/>
              <a:ext cx="612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4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s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+/-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3" name="Straight Connector 142"/>
            <p:cNvCxnSpPr/>
            <p:nvPr/>
          </p:nvCxnSpPr>
          <p:spPr>
            <a:xfrm>
              <a:off x="2520908" y="1000676"/>
              <a:ext cx="13652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/>
            <p:cNvSpPr txBox="1"/>
            <p:nvPr/>
          </p:nvSpPr>
          <p:spPr>
            <a:xfrm>
              <a:off x="2886584" y="794936"/>
              <a:ext cx="6757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2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008120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201160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4394200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587240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4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4780280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973320" y="1224435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 rot="16200000">
              <a:off x="4993724" y="1066869"/>
              <a:ext cx="612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4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s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+/-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2" name="Straight Connector 151"/>
            <p:cNvCxnSpPr/>
            <p:nvPr/>
          </p:nvCxnSpPr>
          <p:spPr>
            <a:xfrm>
              <a:off x="4072234" y="1000676"/>
              <a:ext cx="13652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52"/>
            <p:cNvSpPr txBox="1"/>
            <p:nvPr/>
          </p:nvSpPr>
          <p:spPr>
            <a:xfrm>
              <a:off x="4343400" y="794936"/>
              <a:ext cx="6757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2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4" name="Group 113"/>
          <p:cNvGrpSpPr/>
          <p:nvPr/>
        </p:nvGrpSpPr>
        <p:grpSpPr>
          <a:xfrm>
            <a:off x="350520" y="3004738"/>
            <a:ext cx="6050280" cy="2405463"/>
            <a:chOff x="350520" y="2776137"/>
            <a:chExt cx="6050280" cy="2405463"/>
          </a:xfrm>
        </p:grpSpPr>
        <p:sp>
          <p:nvSpPr>
            <p:cNvPr id="57" name="TextBox 56"/>
            <p:cNvSpPr txBox="1"/>
            <p:nvPr/>
          </p:nvSpPr>
          <p:spPr>
            <a:xfrm>
              <a:off x="444500" y="2776137"/>
              <a:ext cx="3327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9" name="Picture 5" descr="C:\Users\PENG\Desktop\Picture3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0120" y="3810000"/>
              <a:ext cx="544068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3" name="TextBox 162"/>
            <p:cNvSpPr txBox="1"/>
            <p:nvPr/>
          </p:nvSpPr>
          <p:spPr>
            <a:xfrm>
              <a:off x="889000" y="3629898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082040" y="3629898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275080" y="3629898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468120" y="3629898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4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661160" y="3629898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1854200" y="3629898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 rot="16200000">
              <a:off x="1874604" y="3472334"/>
              <a:ext cx="612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4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s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+/-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0" name="Straight Connector 169"/>
            <p:cNvCxnSpPr/>
            <p:nvPr/>
          </p:nvCxnSpPr>
          <p:spPr>
            <a:xfrm>
              <a:off x="953114" y="3406141"/>
              <a:ext cx="13652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/>
            <p:cNvSpPr txBox="1"/>
            <p:nvPr/>
          </p:nvSpPr>
          <p:spPr>
            <a:xfrm>
              <a:off x="1353820" y="3200401"/>
              <a:ext cx="6757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350520" y="3615522"/>
              <a:ext cx="6146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S</a:t>
              </a:r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mple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358140" y="3175085"/>
              <a:ext cx="6146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Primer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4" name="Straight Connector 173"/>
            <p:cNvCxnSpPr/>
            <p:nvPr/>
          </p:nvCxnSpPr>
          <p:spPr>
            <a:xfrm>
              <a:off x="436880" y="3406141"/>
              <a:ext cx="373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/>
            <p:cNvSpPr txBox="1"/>
            <p:nvPr/>
          </p:nvSpPr>
          <p:spPr>
            <a:xfrm>
              <a:off x="2439014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2632054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2825094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3018134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4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211174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3404214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 rot="16200000">
              <a:off x="3424618" y="3473603"/>
              <a:ext cx="612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4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s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+/-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2" name="Straight Connector 181"/>
            <p:cNvCxnSpPr/>
            <p:nvPr/>
          </p:nvCxnSpPr>
          <p:spPr>
            <a:xfrm>
              <a:off x="2503128" y="3407411"/>
              <a:ext cx="13652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Box 182"/>
            <p:cNvSpPr txBox="1"/>
            <p:nvPr/>
          </p:nvSpPr>
          <p:spPr>
            <a:xfrm>
              <a:off x="2903834" y="3201670"/>
              <a:ext cx="6757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3990340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4183380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2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4376420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4569460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4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4762500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5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4955540" y="3631169"/>
              <a:ext cx="335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A6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 rot="16200000">
              <a:off x="4975944" y="3473603"/>
              <a:ext cx="612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en-US" sz="4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s 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+/-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1" name="Straight Connector 190"/>
            <p:cNvCxnSpPr/>
            <p:nvPr/>
          </p:nvCxnSpPr>
          <p:spPr>
            <a:xfrm>
              <a:off x="4054454" y="3407411"/>
              <a:ext cx="13652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TextBox 191"/>
            <p:cNvSpPr txBox="1"/>
            <p:nvPr/>
          </p:nvSpPr>
          <p:spPr>
            <a:xfrm>
              <a:off x="4455160" y="3201670"/>
              <a:ext cx="6757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zh-CN" sz="900" dirty="0" smtClean="0">
                  <a:latin typeface="Arial" pitchFamily="34" charset="0"/>
                  <a:cs typeface="Arial" pitchFamily="34" charset="0"/>
                </a:rPr>
                <a:t>1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7" name="TextBox 196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1</a:t>
            </a:r>
            <a:endParaRPr lang="en-US" sz="20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599091" y="5555398"/>
            <a:ext cx="5508647" cy="861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</a:t>
            </a:r>
            <a:r>
              <a:rPr lang="en-US" altLang="zh-CN" sz="1200" dirty="0" smtClean="0"/>
              <a:t>igure S1 Two representative results of checking A1-A6 background  using ISSR primer (A) and SSRs</a:t>
            </a:r>
            <a:r>
              <a:rPr lang="zh-CN" altLang="en-US" sz="1200" dirty="0"/>
              <a:t> </a:t>
            </a:r>
            <a:r>
              <a:rPr lang="en-US" altLang="zh-CN" sz="1200" dirty="0" smtClean="0"/>
              <a:t>(B). The sequences of ISSR primer W23, W25 and W26 are ACCACCACCACCACC,  ATGATGATGATGATG, and CTCCTCCTCCTCCTC, respectively . The SSR primers W11, W12 and W13 are RM16, RM23 and RM25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55656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8:38Z</dcterms:modified>
</cp:coreProperties>
</file>